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32588" cy="98567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6465F3-8094-4A3E-83B2-7159F272221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9ED0FB-D7E4-49A1-B917-F8B69A3DC3D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D33AFA-D446-4012-9309-8878A20D579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4A407A-E63D-4612-AB7D-CCA48EC7A54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392F6E-35B9-490A-A37F-655D1FDA6EF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E6EA11-35E8-48F3-8DBB-7569C6DC2D8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3F4CAF-E330-4F07-8337-322927FC969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787AA2-A3D5-44ED-B4DE-2CED8F43FF2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5D336D-48D6-464F-9F71-B190CAF0B91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233144-2263-4657-AB46-4D27A77339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CB720C-1C22-4681-B242-7506C80AB44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0457B2-D760-4094-8292-E75F1E3F635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15F612E-F6B8-41A9-886E-2A0E55B162EC}" type="slidenum"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685800" y="7299360"/>
            <a:ext cx="5562720" cy="115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000" spc="-1" strike="noStrike">
                <a:solidFill>
                  <a:srgbClr val="000000"/>
                </a:solidFill>
                <a:latin typeface="Times New Roman"/>
              </a:rPr>
              <a:t>Supplementary Figure 4. </a:t>
            </a:r>
            <a:r>
              <a:rPr b="1" lang="en-IE" sz="1000" spc="-1" strike="noStrike">
                <a:solidFill>
                  <a:srgbClr val="000000"/>
                </a:solidFill>
                <a:latin typeface="Times New Roman"/>
              </a:rPr>
              <a:t>Regulation of gene expression by cyclooxgenase-2 in a range of cell systems</a:t>
            </a:r>
            <a:r>
              <a:rPr b="0" lang="en-IE" sz="1000" spc="-1" strike="noStrike">
                <a:solidFill>
                  <a:srgbClr val="000000"/>
                </a:solidFill>
                <a:latin typeface="Times New Roman"/>
              </a:rPr>
              <a:t>. The Venn diagram shows a cluster of genes which show regulation in one or more COX-2 inhibitor expression datasets (described in blue). The datasets are HCA7 cells (+/- SC-236) (</a:t>
            </a:r>
            <a:r>
              <a:rPr b="0" i="1" lang="en-IE" sz="1000" spc="-1" strike="noStrike">
                <a:solidFill>
                  <a:srgbClr val="000000"/>
                </a:solidFill>
                <a:latin typeface="Times New Roman"/>
              </a:rPr>
              <a:t>top right, </a:t>
            </a:r>
            <a:r>
              <a:rPr b="0" lang="en-IE" sz="1000" spc="-1" strike="noStrike">
                <a:solidFill>
                  <a:srgbClr val="000000"/>
                </a:solidFill>
                <a:latin typeface="Times New Roman"/>
              </a:rPr>
              <a:t>our dataset), 184 htert mammary epithelial cells (+/- celecoxib) (</a:t>
            </a:r>
            <a:r>
              <a:rPr b="0" i="1" lang="en-IE" sz="1000" spc="-1" strike="noStrike">
                <a:solidFill>
                  <a:srgbClr val="000000"/>
                </a:solidFill>
                <a:latin typeface="Times New Roman"/>
              </a:rPr>
              <a:t>top left, </a:t>
            </a:r>
            <a:r>
              <a:rPr b="0" lang="en-IE" sz="1000" spc="-1" strike="noStrike">
                <a:solidFill>
                  <a:srgbClr val="000000"/>
                </a:solidFill>
                <a:latin typeface="Times New Roman"/>
              </a:rPr>
              <a:t>Levitt at al, 2004) and SW480/SW948 cells (+/- sulindac) (</a:t>
            </a:r>
            <a:r>
              <a:rPr b="0" i="1" lang="en-IE" sz="1000" spc="-1" strike="noStrike">
                <a:solidFill>
                  <a:srgbClr val="000000"/>
                </a:solidFill>
                <a:latin typeface="Times New Roman"/>
              </a:rPr>
              <a:t>bottom, </a:t>
            </a:r>
            <a:r>
              <a:rPr b="0" lang="en-IE" sz="1000" spc="-1" strike="noStrike">
                <a:solidFill>
                  <a:srgbClr val="000000"/>
                </a:solidFill>
                <a:latin typeface="Times New Roman"/>
              </a:rPr>
              <a:t>Iizaka et al, 2002). In addition genes which show co-periodicity of expression with DRAK2 with cell cycle progression in Hela cells (from Supp. Figure 3) are highlighted in red.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42" name=""/>
          <p:cNvGrpSpPr/>
          <p:nvPr/>
        </p:nvGrpSpPr>
        <p:grpSpPr>
          <a:xfrm>
            <a:off x="549360" y="971640"/>
            <a:ext cx="5543640" cy="5984280"/>
            <a:chOff x="549360" y="971640"/>
            <a:chExt cx="5543640" cy="5984280"/>
          </a:xfrm>
        </p:grpSpPr>
        <p:sp>
          <p:nvSpPr>
            <p:cNvPr id="43" name=""/>
            <p:cNvSpPr/>
            <p:nvPr/>
          </p:nvSpPr>
          <p:spPr>
            <a:xfrm>
              <a:off x="1197000" y="1403280"/>
              <a:ext cx="3024360" cy="280836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3068640" y="1403280"/>
              <a:ext cx="3024360" cy="280836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2060640" y="2987640"/>
              <a:ext cx="3024360" cy="280836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3213360" y="2682720"/>
              <a:ext cx="12254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E" sz="1400" spc="-1" strike="noStrike">
                  <a:solidFill>
                    <a:srgbClr val="800000"/>
                  </a:solidFill>
                  <a:latin typeface="Arial"/>
                </a:rPr>
                <a:t>DRAK2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3284640" y="3187800"/>
              <a:ext cx="12254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E" sz="1400" spc="-1" strike="noStrike">
                  <a:solidFill>
                    <a:srgbClr val="800000"/>
                  </a:solidFill>
                  <a:latin typeface="Arial"/>
                </a:rPr>
                <a:t>KLF6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3213360" y="1979640"/>
              <a:ext cx="12254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E" sz="1400" spc="-1" strike="noStrike">
                  <a:solidFill>
                    <a:srgbClr val="000000"/>
                  </a:solidFill>
                  <a:latin typeface="Arial"/>
                </a:rPr>
                <a:t>p21 </a:t>
              </a:r>
              <a:r>
                <a:rPr b="1" lang="en-IE" sz="1400" spc="-1" strike="noStrike" baseline="30000">
                  <a:solidFill>
                    <a:srgbClr val="000000"/>
                  </a:solidFill>
                  <a:latin typeface="Arial"/>
                </a:rPr>
                <a:t>CIP1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1700280" y="1835280"/>
              <a:ext cx="12254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E" sz="1400" spc="-1" strike="noStrike">
                  <a:solidFill>
                    <a:srgbClr val="800000"/>
                  </a:solidFill>
                  <a:latin typeface="Arial"/>
                </a:rPr>
                <a:t>CLAFR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3355920" y="1098720"/>
              <a:ext cx="1225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E" sz="1400" spc="-1" strike="noStrike">
                  <a:solidFill>
                    <a:srgbClr val="800000"/>
                  </a:solidFill>
                  <a:latin typeface="Arial"/>
                </a:rPr>
                <a:t>p27 </a:t>
              </a:r>
              <a:r>
                <a:rPr b="1" lang="en-IE" sz="1400" spc="-1" strike="noStrike" baseline="30000">
                  <a:solidFill>
                    <a:srgbClr val="800000"/>
                  </a:solidFill>
                  <a:latin typeface="Arial"/>
                </a:rPr>
                <a:t>Kip1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549360" y="1258920"/>
              <a:ext cx="22320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E" sz="1400" spc="-1" strike="noStrike">
                  <a:solidFill>
                    <a:srgbClr val="000066"/>
                  </a:solidFill>
                  <a:latin typeface="Arial"/>
                </a:rPr>
                <a:t>Celecoxib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3068640" y="5996160"/>
              <a:ext cx="22320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E" sz="1400" spc="-1" strike="noStrike">
                  <a:solidFill>
                    <a:srgbClr val="000066"/>
                  </a:solidFill>
                  <a:latin typeface="Arial"/>
                </a:rPr>
                <a:t>Sulindac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2276640" y="3762360"/>
              <a:ext cx="11523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E" sz="1400" spc="-1" strike="noStrike">
                  <a:solidFill>
                    <a:srgbClr val="000000"/>
                  </a:solidFill>
                  <a:latin typeface="Arial"/>
                </a:rPr>
                <a:t>GADD45a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3213360" y="2322360"/>
              <a:ext cx="12952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E" sz="1400" spc="-1" strike="noStrike">
                  <a:solidFill>
                    <a:srgbClr val="000000"/>
                  </a:solidFill>
                  <a:latin typeface="Arial"/>
                </a:rPr>
                <a:t>CREB1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3141720" y="6324480"/>
              <a:ext cx="1008000" cy="631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E" sz="1400" spc="-1" strike="noStrike">
                  <a:solidFill>
                    <a:srgbClr val="000066"/>
                  </a:solidFill>
                  <a:latin typeface="Arial"/>
                </a:rPr>
                <a:t>SW480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E" sz="1400" spc="-1" strike="noStrike">
                  <a:solidFill>
                    <a:srgbClr val="000066"/>
                  </a:solidFill>
                  <a:latin typeface="Arial"/>
                </a:rPr>
                <a:t>SW948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549360" y="971640"/>
              <a:ext cx="10080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E" sz="1400" spc="-1" strike="noStrike">
                  <a:solidFill>
                    <a:srgbClr val="000066"/>
                  </a:solidFill>
                  <a:latin typeface="Arial"/>
                </a:rPr>
                <a:t>184htert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2492640" y="1547640"/>
              <a:ext cx="934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E" sz="1400" spc="-1" strike="noStrike">
                  <a:solidFill>
                    <a:srgbClr val="800000"/>
                  </a:solidFill>
                  <a:latin typeface="Arial"/>
                </a:rPr>
                <a:t>BMP2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4222800" y="1603440"/>
              <a:ext cx="934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E" sz="1400" spc="-1" strike="noStrike">
                  <a:solidFill>
                    <a:srgbClr val="000000"/>
                  </a:solidFill>
                  <a:latin typeface="Arial"/>
                </a:rPr>
                <a:t>BMP4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3932280" y="3780000"/>
              <a:ext cx="1152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E" sz="1400" spc="-1" strike="noStrike">
                  <a:solidFill>
                    <a:srgbClr val="000000"/>
                  </a:solidFill>
                  <a:latin typeface="Arial"/>
                </a:rPr>
                <a:t>GADD34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2565360" y="3403440"/>
              <a:ext cx="1225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E" sz="1400" spc="-1" strike="noStrike">
                  <a:solidFill>
                    <a:srgbClr val="000000"/>
                  </a:solidFill>
                  <a:latin typeface="Arial"/>
                </a:rPr>
                <a:t>KLF5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3213360" y="4195800"/>
              <a:ext cx="10080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E" sz="1400" spc="-1" strike="noStrike">
                  <a:solidFill>
                    <a:srgbClr val="000000"/>
                  </a:solidFill>
                  <a:latin typeface="Arial"/>
                </a:rPr>
                <a:t>DAPK3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2205000" y="4483080"/>
              <a:ext cx="9352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E" sz="1400" spc="-1" strike="noStrike">
                  <a:solidFill>
                    <a:srgbClr val="000000"/>
                  </a:solidFill>
                  <a:latin typeface="Arial"/>
                </a:rPr>
                <a:t>C/EBP</a:t>
              </a:r>
              <a:r>
                <a:rPr b="1" lang="en-IE" sz="14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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1197000" y="2627280"/>
              <a:ext cx="9352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E" sz="1400" spc="-1" strike="noStrike">
                  <a:solidFill>
                    <a:srgbClr val="000000"/>
                  </a:solidFill>
                  <a:latin typeface="Arial"/>
                </a:rPr>
                <a:t>C/EBP</a:t>
              </a:r>
              <a:r>
                <a:rPr b="1" lang="en-IE" sz="14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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1413000" y="3132000"/>
              <a:ext cx="934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E" sz="1400" spc="-1" strike="noStrike">
                  <a:solidFill>
                    <a:srgbClr val="000000"/>
                  </a:solidFill>
                  <a:latin typeface="Arial"/>
                </a:rPr>
                <a:t>C/EBP</a:t>
              </a:r>
              <a:r>
                <a:rPr b="1" lang="en-IE" sz="14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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3213360" y="4716360"/>
              <a:ext cx="9363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E" sz="1400" spc="-1" strike="noStrike">
                  <a:solidFill>
                    <a:srgbClr val="800000"/>
                  </a:solidFill>
                  <a:latin typeface="Arial"/>
                </a:rPr>
                <a:t>MUC1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4364280" y="2268360"/>
              <a:ext cx="12254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E" sz="1400" spc="-1" strike="noStrike">
                  <a:solidFill>
                    <a:srgbClr val="000000"/>
                  </a:solidFill>
                  <a:latin typeface="Arial"/>
                </a:rPr>
                <a:t>H4 histone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1916280" y="2268360"/>
              <a:ext cx="12254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E" sz="1400" spc="-1" strike="noStrike">
                  <a:solidFill>
                    <a:srgbClr val="800000"/>
                  </a:solidFill>
                  <a:latin typeface="Arial"/>
                </a:rPr>
                <a:t>H2 histone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2853000" y="5219640"/>
              <a:ext cx="18000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E" sz="1400" spc="-1" strike="noStrike">
                  <a:solidFill>
                    <a:srgbClr val="000000"/>
                  </a:solidFill>
                  <a:latin typeface="Arial"/>
                </a:rPr>
                <a:t>ATF3    STC2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69" name=""/>
          <p:cNvSpPr/>
          <p:nvPr/>
        </p:nvSpPr>
        <p:spPr>
          <a:xfrm>
            <a:off x="5734080" y="1042920"/>
            <a:ext cx="1440000" cy="631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E" sz="1400" spc="-1" strike="noStrike">
                <a:solidFill>
                  <a:srgbClr val="000066"/>
                </a:solidFill>
                <a:latin typeface="Arial"/>
              </a:rPr>
              <a:t>HCA7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E" sz="1400" spc="-1" strike="noStrike">
                <a:solidFill>
                  <a:srgbClr val="000066"/>
                </a:solidFill>
                <a:latin typeface="Arial"/>
              </a:rPr>
              <a:t>SC236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4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4-22T19:24:48Z</dcterms:created>
  <dc:creator/>
  <dc:description/>
  <dc:language>en-US</dc:language>
  <cp:lastModifiedBy>John O'Dowd</cp:lastModifiedBy>
  <dcterms:modified xsi:type="dcterms:W3CDTF">2009-05-07T19:00:44Z</dcterms:modified>
  <cp:revision>39</cp:revision>
  <dc:subject/>
  <dc:title>PowerPoint Presentation</dc:title>
</cp:coreProperties>
</file>